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2" d="100"/>
          <a:sy n="52" d="100"/>
        </p:scale>
        <p:origin x="246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240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4043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2565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9500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724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7950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9905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4931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5413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2904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4908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3261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0" y="8691800"/>
            <a:ext cx="685800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Supplementary Figure 1</a:t>
            </a:r>
            <a:r>
              <a:rPr lang="en-US" sz="1100" dirty="0" smtClean="0"/>
              <a:t> – </a:t>
            </a:r>
            <a:r>
              <a:rPr lang="en-US" sz="1100" dirty="0"/>
              <a:t>Principal Component Analysis (PCA) of </a:t>
            </a:r>
            <a:r>
              <a:rPr lang="en-US" sz="1100" dirty="0" smtClean="0"/>
              <a:t>DNA </a:t>
            </a:r>
            <a:r>
              <a:rPr lang="en-US" sz="1100" dirty="0"/>
              <a:t>methylation profiles </a:t>
            </a:r>
            <a:r>
              <a:rPr lang="en-US" sz="1100" dirty="0" smtClean="0"/>
              <a:t>from all CMS2 and CMS3 samples present in the MATCH and TCGA cohorts</a:t>
            </a:r>
          </a:p>
          <a:p>
            <a:endParaRPr lang="en-GB" sz="1100" dirty="0"/>
          </a:p>
          <a:p>
            <a:r>
              <a:rPr lang="en-US" sz="1100" dirty="0"/>
              <a:t>Principal components were calculated for DNA methylation profiles of 286 colorectal cancer tissues (146 from MATCH cohort (black) and 140 from TCGA </a:t>
            </a:r>
            <a:r>
              <a:rPr lang="en-US" sz="1100" dirty="0" smtClean="0"/>
              <a:t>cohort). In </a:t>
            </a:r>
            <a:r>
              <a:rPr lang="en-US" sz="1100" b="1" dirty="0" smtClean="0"/>
              <a:t>A. </a:t>
            </a:r>
            <a:r>
              <a:rPr lang="en-US" sz="1100" dirty="0" smtClean="0"/>
              <a:t>PC1 is shown on the X-axis and PC2 on the y-axis. In </a:t>
            </a:r>
            <a:r>
              <a:rPr lang="en-US" sz="1100" b="1" dirty="0" smtClean="0"/>
              <a:t>B. </a:t>
            </a:r>
            <a:r>
              <a:rPr lang="en-US" sz="1100" dirty="0" smtClean="0"/>
              <a:t>PC1 is shown on the x-axis and PC3 in the y-axis. In </a:t>
            </a:r>
            <a:r>
              <a:rPr lang="en-US" sz="1100" b="1" dirty="0" smtClean="0"/>
              <a:t>C. </a:t>
            </a:r>
            <a:r>
              <a:rPr lang="en-US" sz="1100" dirty="0" smtClean="0"/>
              <a:t>PC2 is shown on the x-axis and PC3 on the y-axis. Each dot represents 1 sample. </a:t>
            </a:r>
            <a:r>
              <a:rPr lang="en-US" sz="1100" dirty="0"/>
              <a:t>Samples are </a:t>
            </a:r>
            <a:r>
              <a:rPr lang="en-US" sz="1100" dirty="0" smtClean="0"/>
              <a:t>colored </a:t>
            </a:r>
            <a:r>
              <a:rPr lang="en-US" sz="1100" dirty="0"/>
              <a:t>based on their cohort of origin (MATCH in black and TCGA </a:t>
            </a:r>
            <a:r>
              <a:rPr lang="en-US" sz="1100" dirty="0" smtClean="0"/>
              <a:t>in red).</a:t>
            </a:r>
            <a:endParaRPr lang="en-US" sz="1100" dirty="0"/>
          </a:p>
        </p:txBody>
      </p:sp>
      <p:grpSp>
        <p:nvGrpSpPr>
          <p:cNvPr id="19" name="Group 18"/>
          <p:cNvGrpSpPr/>
          <p:nvPr/>
        </p:nvGrpSpPr>
        <p:grpSpPr>
          <a:xfrm>
            <a:off x="133350" y="5829"/>
            <a:ext cx="6519943" cy="8426682"/>
            <a:chOff x="133350" y="5829"/>
            <a:chExt cx="6519943" cy="8426682"/>
          </a:xfrm>
        </p:grpSpPr>
        <p:grpSp>
          <p:nvGrpSpPr>
            <p:cNvPr id="6" name="Group 5"/>
            <p:cNvGrpSpPr/>
            <p:nvPr/>
          </p:nvGrpSpPr>
          <p:grpSpPr>
            <a:xfrm>
              <a:off x="4957843" y="1156777"/>
              <a:ext cx="1695450" cy="513695"/>
              <a:chOff x="5988080" y="6900233"/>
              <a:chExt cx="1695450" cy="513695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6521480" y="6900233"/>
                <a:ext cx="11620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100" dirty="0" smtClean="0"/>
                  <a:t>TCGA</a:t>
                </a:r>
                <a:endParaRPr lang="en-GB" sz="1100" dirty="0"/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5988080" y="7221336"/>
                <a:ext cx="542926" cy="123575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521480" y="7152318"/>
                <a:ext cx="11620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100" dirty="0" smtClean="0"/>
                  <a:t>MATCH</a:t>
                </a:r>
                <a:endParaRPr lang="en-GB" sz="1100" dirty="0"/>
              </a:p>
            </p:txBody>
          </p:sp>
          <p:sp>
            <p:nvSpPr>
              <p:cNvPr id="10" name="Rectangle 9"/>
              <p:cNvSpPr/>
              <p:nvPr/>
            </p:nvSpPr>
            <p:spPr>
              <a:xfrm>
                <a:off x="5988080" y="6978323"/>
                <a:ext cx="542926" cy="1235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4957843" y="6767869"/>
              <a:ext cx="1695450" cy="513695"/>
              <a:chOff x="5988080" y="6900233"/>
              <a:chExt cx="1695450" cy="513695"/>
            </a:xfrm>
          </p:grpSpPr>
          <p:sp>
            <p:nvSpPr>
              <p:cNvPr id="14" name="TextBox 13"/>
              <p:cNvSpPr txBox="1"/>
              <p:nvPr/>
            </p:nvSpPr>
            <p:spPr>
              <a:xfrm>
                <a:off x="6521480" y="6900233"/>
                <a:ext cx="11620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100" dirty="0" smtClean="0"/>
                  <a:t>TCGA</a:t>
                </a:r>
                <a:endParaRPr lang="en-GB" sz="1100" dirty="0"/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5988080" y="7221336"/>
                <a:ext cx="542926" cy="123575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6521480" y="7152318"/>
                <a:ext cx="11620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100" dirty="0" smtClean="0"/>
                  <a:t>MATCH</a:t>
                </a:r>
                <a:endParaRPr lang="en-GB" sz="1100" dirty="0"/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5988080" y="6978323"/>
                <a:ext cx="542926" cy="1235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4957843" y="3960747"/>
              <a:ext cx="1695450" cy="513695"/>
              <a:chOff x="5988080" y="6900233"/>
              <a:chExt cx="1695450" cy="513695"/>
            </a:xfrm>
          </p:grpSpPr>
          <p:sp>
            <p:nvSpPr>
              <p:cNvPr id="21" name="TextBox 20"/>
              <p:cNvSpPr txBox="1"/>
              <p:nvPr/>
            </p:nvSpPr>
            <p:spPr>
              <a:xfrm>
                <a:off x="6521480" y="6900233"/>
                <a:ext cx="11620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100" dirty="0" smtClean="0"/>
                  <a:t>TCGA</a:t>
                </a:r>
                <a:endParaRPr lang="en-GB" sz="1100" dirty="0"/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5988080" y="7221336"/>
                <a:ext cx="542926" cy="123575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6521480" y="7152318"/>
                <a:ext cx="11620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100" dirty="0" smtClean="0"/>
                  <a:t>MATCH</a:t>
                </a:r>
                <a:endParaRPr lang="en-GB" sz="1100" dirty="0"/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5988080" y="6978323"/>
                <a:ext cx="542926" cy="1235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6" name="TextBox 25"/>
            <p:cNvSpPr txBox="1"/>
            <p:nvPr/>
          </p:nvSpPr>
          <p:spPr>
            <a:xfrm>
              <a:off x="133350" y="320793"/>
              <a:ext cx="5905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100" b="1" dirty="0" smtClean="0"/>
                <a:t>A.</a:t>
              </a:r>
              <a:endParaRPr lang="en-GB" sz="110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33350" y="3140736"/>
              <a:ext cx="5905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100" b="1" dirty="0"/>
                <a:t>B</a:t>
              </a:r>
              <a:r>
                <a:rPr lang="nl-NL" sz="1100" b="1" dirty="0" smtClean="0"/>
                <a:t>.</a:t>
              </a:r>
              <a:endParaRPr lang="en-GB" sz="11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33350" y="5946707"/>
              <a:ext cx="5905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100" b="1" dirty="0" smtClean="0"/>
                <a:t>C.</a:t>
              </a:r>
              <a:endParaRPr lang="en-GB" sz="1100" b="1" dirty="0"/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3963" y="5829"/>
              <a:ext cx="4107180" cy="281559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8589" y="2809799"/>
              <a:ext cx="4107180" cy="2815590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3215" y="5616921"/>
              <a:ext cx="4107180" cy="281559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277707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135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Erasmus 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.M. Wilting</dc:creator>
  <cp:lastModifiedBy>Inge van den Berg</cp:lastModifiedBy>
  <cp:revision>7</cp:revision>
  <dcterms:created xsi:type="dcterms:W3CDTF">2021-06-02T08:41:55Z</dcterms:created>
  <dcterms:modified xsi:type="dcterms:W3CDTF">2021-08-04T13:14:55Z</dcterms:modified>
</cp:coreProperties>
</file>